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3" r:id="rId2"/>
  </p:sldIdLst>
  <p:sldSz cx="9144000" cy="6858000" type="screen4x3"/>
  <p:notesSz cx="6858000" cy="9144000"/>
  <p:custDataLst>
    <p:tags r:id="rId4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  <a:srgbClr val="008000"/>
    <a:srgbClr val="996600"/>
    <a:srgbClr val="006600"/>
    <a:srgbClr val="990099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4585" autoAdjust="0"/>
  </p:normalViewPr>
  <p:slideViewPr>
    <p:cSldViewPr snapToGrid="0">
      <p:cViewPr>
        <p:scale>
          <a:sx n="80" d="100"/>
          <a:sy n="80" d="100"/>
        </p:scale>
        <p:origin x="-912" y="-5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82" d="100"/>
          <a:sy n="82" d="100"/>
        </p:scale>
        <p:origin x="-3936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A0EE6-1AEB-4320-B071-D9A4A03B3ED2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0A0E9E-2ACA-44AD-BEF1-031FA851C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10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9E469-D60F-4038-B20E-723A0D3FB216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6B4CF4-3EC9-4213-A168-B5FF11E57D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4EF24E-8986-4213-878A-B70333F0BDF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7FF9A3-B42B-4301-8C30-D0E7772DBAB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94077C-1FC4-4B66-9434-D9D2F68D1A5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39DDA8-9250-472A-B0AD-28FCB24525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9F89D9-F6B2-49C8-8600-62354FA59D0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608677-5349-42D8-A5EC-1DD6F1E730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8B91F1-F8B8-42D4-96AC-01D5829B989D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5383A1-6872-4BDD-A0CA-8E5E7D54B27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B64BF-A1DF-44DC-BB50-5C1B31AADA9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082968-46A5-49FB-843B-968C60F7B8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863F39-56A7-4BDD-9BDF-CE2ED9617389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3D7A67-603A-4443-B981-FED77F8B8BC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72829A-F9AD-4F85-8742-A7921280B49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E9FB66-E665-4ECA-B3BF-6757A74945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B7FD3-B99E-4187-9933-AC9AB1DB312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EA5B27-D46A-45E5-997E-51E74B173B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536B44-95B8-4C0A-995D-B6DA8903392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5727CC-AEDC-4499-97F7-F71B072ABA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E4FE53-0901-46B4-BB33-B6E688B1B94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47EBED-B686-4F5E-AA92-8267F9708D3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614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1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D707B30-B607-4830-AF03-751890073B6C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53FBA08-8B6C-4D0B-A2C0-C870076B75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295400" y="688490"/>
            <a:ext cx="6629400" cy="4797929"/>
            <a:chOff x="1295400" y="688490"/>
            <a:chExt cx="6629400" cy="4797929"/>
          </a:xfrm>
        </p:grpSpPr>
        <p:grpSp>
          <p:nvGrpSpPr>
            <p:cNvPr id="2" name="Group 3"/>
            <p:cNvGrpSpPr>
              <a:grpSpLocks/>
            </p:cNvGrpSpPr>
            <p:nvPr/>
          </p:nvGrpSpPr>
          <p:grpSpPr bwMode="auto">
            <a:xfrm>
              <a:off x="1384300" y="688490"/>
              <a:ext cx="6464300" cy="4797929"/>
              <a:chOff x="1753560" y="1510145"/>
              <a:chExt cx="5322600" cy="4122053"/>
            </a:xfrm>
          </p:grpSpPr>
          <p:pic>
            <p:nvPicPr>
              <p:cNvPr id="14341" name="Picture 3"/>
              <p:cNvPicPr>
                <a:picLocks noChangeAspect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4431240" y="1704240"/>
                <a:ext cx="2603880" cy="1771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42" name="Picture 4"/>
              <p:cNvPicPr>
                <a:picLocks noChangeAspect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775520" y="1734840"/>
                <a:ext cx="2438280" cy="1740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43" name="Picture 5"/>
              <p:cNvPicPr>
                <a:picLocks noChangeAspect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753560" y="3608639"/>
                <a:ext cx="2601360" cy="18593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44" name="Picture 6"/>
              <p:cNvPicPr>
                <a:picLocks noChangeAspect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4431240" y="3608639"/>
                <a:ext cx="2644920" cy="202355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45" name="Picture 7"/>
              <p:cNvPicPr>
                <a:picLocks noChangeAspect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1876680" y="1510145"/>
                <a:ext cx="420840" cy="4935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46" name="Picture 8"/>
              <p:cNvPicPr>
                <a:picLocks noChangeAspect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4537440" y="1517196"/>
                <a:ext cx="414360" cy="4935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47" name="Picture 9"/>
              <p:cNvPicPr>
                <a:picLocks noChangeAspect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1845214" y="3407998"/>
                <a:ext cx="407880" cy="4935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4348" name="Picture 10"/>
              <p:cNvPicPr>
                <a:picLocks noChangeAspect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4524839" y="3408745"/>
                <a:ext cx="426960" cy="4935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13" name="Rectangle 12"/>
            <p:cNvSpPr/>
            <p:nvPr/>
          </p:nvSpPr>
          <p:spPr>
            <a:xfrm>
              <a:off x="1295400" y="838200"/>
              <a:ext cx="6629400" cy="4648200"/>
            </a:xfrm>
            <a:prstGeom prst="rect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V="1">
              <a:off x="1828800" y="1219200"/>
              <a:ext cx="0" cy="1802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 flipH="1" flipV="1">
              <a:off x="5530795" y="1143000"/>
              <a:ext cx="3313" cy="17691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 flipH="1" flipV="1">
              <a:off x="1858618" y="3585394"/>
              <a:ext cx="3313" cy="17691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H="1" flipV="1">
              <a:off x="5740180" y="3491286"/>
              <a:ext cx="3313" cy="17691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Rectangle 2"/>
          <p:cNvSpPr/>
          <p:nvPr/>
        </p:nvSpPr>
        <p:spPr>
          <a:xfrm>
            <a:off x="510639" y="5593141"/>
            <a:ext cx="839585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smtClean="0"/>
              <a:t>Additional file </a:t>
            </a:r>
            <a:r>
              <a:rPr lang="en-US" sz="1200" b="1" smtClean="0"/>
              <a:t>8: </a:t>
            </a:r>
            <a:r>
              <a:rPr lang="en-US" sz="1200" dirty="0"/>
              <a:t>Diurnal expression of some rice genes. Arrows indicate (A) pre-dawn peak in bHLH60 (LOC_Os08g04390); (B) small crest at mid-day (phase9) in PROLM26 (LOC_Os07g10580); (C) pre-dawn peak in MADS57 (LOC_Os02g49840) and MADS14 (LOC_Os03g54160); (D) end-of-day spike in MADS5 (LOC_Os06g06750; green and magenta) and MADS15 (LOC_Os07g01820; red and orange). The images were downloaded from the DIURNAL website (http://diurnal.mocklerlab.org/). </a:t>
            </a:r>
          </a:p>
        </p:txBody>
      </p:sp>
    </p:spTree>
    <p:extLst>
      <p:ext uri="{BB962C8B-B14F-4D97-AF65-F5344CB8AC3E}">
        <p14:creationId xmlns:p14="http://schemas.microsoft.com/office/powerpoint/2010/main" val="50680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35&quot;&gt;&lt;property id=&quot;20148&quot; value=&quot;5&quot;/&gt;&lt;property id=&quot;20300&quot; value=&quot;Slide 1&quot;/&gt;&lt;property id=&quot;20307&quot; value=&quot;303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pex</Template>
  <TotalTime>11362</TotalTime>
  <Words>8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iswal Lab</dc:creator>
  <cp:lastModifiedBy>Real, Francis Frank</cp:lastModifiedBy>
  <cp:revision>536</cp:revision>
  <dcterms:created xsi:type="dcterms:W3CDTF">2012-03-13T21:10:20Z</dcterms:created>
  <dcterms:modified xsi:type="dcterms:W3CDTF">2013-06-11T10:46:11Z</dcterms:modified>
</cp:coreProperties>
</file>